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1" r:id="rId2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3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9441"/>
    <p:restoredTop sz="94522"/>
  </p:normalViewPr>
  <p:slideViewPr>
    <p:cSldViewPr>
      <p:cViewPr>
        <p:scale>
          <a:sx n="150" d="100"/>
          <a:sy n="150" d="100"/>
        </p:scale>
        <p:origin x="72" y="-78"/>
      </p:cViewPr>
      <p:guideLst>
        <p:guide orient="horz" pos="283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9DE63A-05F3-4ED0-BEE9-4217A22E0FC5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64386A-5E62-4B7F-8466-F9386CEA9FF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84861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961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1691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8989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5730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1843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8604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0874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5939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0735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7148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3503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3293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0" y="0"/>
            <a:ext cx="20053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88276" y="1763688"/>
            <a:ext cx="665309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: Characterization of naïve human HSCs grown on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iOn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covered and uncovered 3D PDMS and collagen- or fibronectin-covered and uncovered PS 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34+ and CD34+/ CD38-/ CD45RA-/ CD49f+/ CD90+ HSC cells after 0 DIV were determined by flow cytometric analyses using a combination of specific antibodies and vital cells were selected using DAPI. 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percentage and absolute number of CD34+ cells as well as the percentage and the absolute number of CD34+/ CD38-/ CD45RA-/ CD49f+/ CD90+ cells are depicted for three different donors as their mean ± SD (A and B show independent experiments). </a:t>
            </a:r>
          </a:p>
        </p:txBody>
      </p:sp>
      <p:sp>
        <p:nvSpPr>
          <p:cNvPr id="13" name="Textfeld 16">
            <a:extLst>
              <a:ext uri="{FF2B5EF4-FFF2-40B4-BE49-F238E27FC236}">
                <a16:creationId xmlns:a16="http://schemas.microsoft.com/office/drawing/2014/main" xmlns="" id="{74183280-FB8D-8A42-A4C5-D186C2AD5EAC}"/>
              </a:ext>
            </a:extLst>
          </p:cNvPr>
          <p:cNvSpPr txBox="1"/>
          <p:nvPr/>
        </p:nvSpPr>
        <p:spPr>
          <a:xfrm>
            <a:off x="-15510" y="318010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feld 16">
            <a:extLst>
              <a:ext uri="{FF2B5EF4-FFF2-40B4-BE49-F238E27FC236}">
                <a16:creationId xmlns:a16="http://schemas.microsoft.com/office/drawing/2014/main" xmlns="" id="{74183280-FB8D-8A42-A4C5-D186C2AD5EAC}"/>
              </a:ext>
            </a:extLst>
          </p:cNvPr>
          <p:cNvSpPr txBox="1"/>
          <p:nvPr/>
        </p:nvSpPr>
        <p:spPr>
          <a:xfrm>
            <a:off x="2708920" y="318009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265" y="344784"/>
            <a:ext cx="877970" cy="1368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016" y="344784"/>
            <a:ext cx="871866" cy="13680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4180" y="348642"/>
            <a:ext cx="837134" cy="1368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7568" y="344784"/>
            <a:ext cx="955636" cy="13680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3478" y="340170"/>
            <a:ext cx="877970" cy="13680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4282" y="348642"/>
            <a:ext cx="909232" cy="136800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7282" y="348642"/>
            <a:ext cx="837134" cy="136800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9961" y="340170"/>
            <a:ext cx="955636" cy="136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108284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15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x-Blümel, Lisa</dc:creator>
  <cp:lastModifiedBy>Jayaseela</cp:lastModifiedBy>
  <cp:revision>603</cp:revision>
  <cp:lastPrinted>2019-07-22T14:46:21Z</cp:lastPrinted>
  <dcterms:created xsi:type="dcterms:W3CDTF">2018-07-30T07:38:54Z</dcterms:created>
  <dcterms:modified xsi:type="dcterms:W3CDTF">2020-06-12T14:45:37Z</dcterms:modified>
</cp:coreProperties>
</file>